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66" d="100"/>
          <a:sy n="66" d="100"/>
        </p:scale>
        <p:origin x="2097" y="9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19C5261-8359-0A7E-6306-023F672F41D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7F5A0B27-B4A7-7557-8DF2-D521CC2B0BE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D77A0BF-516E-F8F7-919A-071AC1EBC2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1DAB1-B041-430B-9A0D-348E88CA23CF}" type="datetimeFigureOut">
              <a:rPr lang="zh-CN" altLang="en-US" smtClean="0"/>
              <a:t>2025/2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2A094C3-D352-39BF-A382-6E0886F7BE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A7AC68E-0057-75C4-1AF4-A230E612BF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F89A49-0E71-45A0-9618-7DD8B6E7E9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90848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8A7347D-46AF-EABC-51C3-9019C87899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79105A7-F4DD-91A5-B23D-5E9921499DF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30B3F3A-92E1-8DE3-2C66-F5263FDD6D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1DAB1-B041-430B-9A0D-348E88CA23CF}" type="datetimeFigureOut">
              <a:rPr lang="zh-CN" altLang="en-US" smtClean="0"/>
              <a:t>2025/2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E1AD860-F765-3C90-930D-446FE1E48A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576E624-E1B4-06F5-4913-0F07439E80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F89A49-0E71-45A0-9618-7DD8B6E7E9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85249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5856D686-3C1F-F9A8-1E5C-6F9EDD65BE3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3C08514-C757-86B2-8EEA-D59B02DE110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D9109EF-BF96-AB90-EE8E-1DF97DE734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1DAB1-B041-430B-9A0D-348E88CA23CF}" type="datetimeFigureOut">
              <a:rPr lang="zh-CN" altLang="en-US" smtClean="0"/>
              <a:t>2025/2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601E4CB-D568-D433-102C-E13C9E1342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08876BD-9D1C-1F15-97F1-45F8F9BF02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F89A49-0E71-45A0-9618-7DD8B6E7E9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32651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5B86D88-D2EC-41D6-7648-1EE5A52729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B6427E2-7B6A-FD0C-C7D7-5F071AFB496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936D507-7BA3-F092-3FD5-0AB39F2312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1DAB1-B041-430B-9A0D-348E88CA23CF}" type="datetimeFigureOut">
              <a:rPr lang="zh-CN" altLang="en-US" smtClean="0"/>
              <a:t>2025/2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CA3439D-11F6-7DBD-7E61-A8F26C81DA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B86913C-3182-46D8-027F-228130C811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F89A49-0E71-45A0-9618-7DD8B6E7E9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343604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51675D7-23DF-D383-0EF2-73C5064B28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243301E-6FBA-05CC-56F1-382F9E97CC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7CA48D3-3746-EE97-1FF9-F12BE86A02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1DAB1-B041-430B-9A0D-348E88CA23CF}" type="datetimeFigureOut">
              <a:rPr lang="zh-CN" altLang="en-US" smtClean="0"/>
              <a:t>2025/2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B379EF1-BB04-4772-9F53-9757AFC5C3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966EA14-206E-3E04-97D7-8E13BD51A7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F89A49-0E71-45A0-9618-7DD8B6E7E9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034881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79FF13C-1B8E-5F23-673C-A9D0035432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2D2AD21-78D5-A995-97F7-8B1D58D62FB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2762F90-ADB0-A777-33FD-B3763C20345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A065C0F-EB73-A09D-D102-70A7265D76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1DAB1-B041-430B-9A0D-348E88CA23CF}" type="datetimeFigureOut">
              <a:rPr lang="zh-CN" altLang="en-US" smtClean="0"/>
              <a:t>2025/2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A5A5AFA-B3BB-110D-6FA8-3C540C2892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2754B78-37A3-5853-DB9D-D03A05A117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F89A49-0E71-45A0-9618-7DD8B6E7E9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695206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32C007E-37FE-2291-0A25-FB9092A67C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8F87E5B-6916-2183-85B9-984C377433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9B54C08-6BB4-E499-EDBF-1B7E7EBE90B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51658293-3ED4-CEC2-C305-E182AD6289E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8E672256-C929-C8AA-A812-D93A461E7B8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8C128DA7-CDE2-5BF5-D171-5CD8CE520E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1DAB1-B041-430B-9A0D-348E88CA23CF}" type="datetimeFigureOut">
              <a:rPr lang="zh-CN" altLang="en-US" smtClean="0"/>
              <a:t>2025/2/2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44F6F09C-DFBD-9E76-C13E-6627A17863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5A8442F4-4664-654A-DFB7-1DE231DFC4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F89A49-0E71-45A0-9618-7DD8B6E7E9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43652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779BC87-4512-0300-17C1-05D74B98DC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68F2D3F1-45BB-AF99-3BBF-4459363730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1DAB1-B041-430B-9A0D-348E88CA23CF}" type="datetimeFigureOut">
              <a:rPr lang="zh-CN" altLang="en-US" smtClean="0"/>
              <a:t>2025/2/2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A46BC49F-909C-59A6-AD1D-84DBBA6A4C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0E0C6122-1F26-CB2B-6C7D-DF37C07FF9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F89A49-0E71-45A0-9618-7DD8B6E7E9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85494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3A136E84-F343-54E3-E0F6-498AEC8095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1DAB1-B041-430B-9A0D-348E88CA23CF}" type="datetimeFigureOut">
              <a:rPr lang="zh-CN" altLang="en-US" smtClean="0"/>
              <a:t>2025/2/2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D5AE3A2A-373F-3CF5-045D-397B713BBF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90EA79E8-5217-4739-EB80-9C984B175F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F89A49-0E71-45A0-9618-7DD8B6E7E9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749841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3B371DE-19D6-E49F-3812-00B073B4F8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91C4C2E-770C-E01A-E2D1-1216812B2DE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C84D073-B63A-9684-696E-78212670D98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12A5D75-E37B-1441-0A97-6A15EDEBF6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1DAB1-B041-430B-9A0D-348E88CA23CF}" type="datetimeFigureOut">
              <a:rPr lang="zh-CN" altLang="en-US" smtClean="0"/>
              <a:t>2025/2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ABC09E6-C5E2-9093-543F-F2376CAC2A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294FA53-6D2D-8F3E-99C6-3DF0C51F21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F89A49-0E71-45A0-9618-7DD8B6E7E9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78907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3B22586-4D85-AB27-9F60-E2709DA95C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26F81AF6-DC57-41B4-8FB6-3DDA1AAB64A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40E20E8D-D83B-6B6F-DACF-2FCF9719486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DFEDB78-1EE0-536F-33CE-F5594E5E15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1DAB1-B041-430B-9A0D-348E88CA23CF}" type="datetimeFigureOut">
              <a:rPr lang="zh-CN" altLang="en-US" smtClean="0"/>
              <a:t>2025/2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AC329BA-FEC2-4B80-6B20-1B799BB9E5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D7056B4-4FF8-432F-D62B-FD5FA94E49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F89A49-0E71-45A0-9618-7DD8B6E7E9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15267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3C6AFB5B-A2DC-4F36-00E3-173A56DF0E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4400450-73CD-45D6-AC35-DD65B80A701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2AF296B-60E6-C876-58B2-B3099DE82EB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A1DAB1-B041-430B-9A0D-348E88CA23CF}" type="datetimeFigureOut">
              <a:rPr lang="zh-CN" altLang="en-US" smtClean="0"/>
              <a:t>2025/2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0B3EDCA-5D84-F8F3-D01B-CAA5CC94E02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EE1BC85-C7D8-F01B-F935-80C4164EA33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F89A49-0E71-45A0-9618-7DD8B6E7E99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206680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FA853EF8-A4DB-B146-C04C-4E193957878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6603" b="3979"/>
          <a:stretch/>
        </p:blipFill>
        <p:spPr>
          <a:xfrm>
            <a:off x="65737" y="2329374"/>
            <a:ext cx="2613900" cy="2438707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DD5916EC-F662-F3D3-7B8A-0202E6F4CE5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54174" y="2320045"/>
            <a:ext cx="2687633" cy="2438707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C3F0B326-C4EC-5195-F030-7EDCF53ED81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295525" y="2338701"/>
            <a:ext cx="2687634" cy="2420051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46C4FBBB-3919-F499-85F6-E0F87B4CD77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436878" y="2329374"/>
            <a:ext cx="2689385" cy="2420050"/>
          </a:xfrm>
          <a:prstGeom prst="rect">
            <a:avLst/>
          </a:prstGeom>
        </p:spPr>
      </p:pic>
      <p:cxnSp>
        <p:nvCxnSpPr>
          <p:cNvPr id="13" name="直接箭头连接符 12">
            <a:extLst>
              <a:ext uri="{FF2B5EF4-FFF2-40B4-BE49-F238E27FC236}">
                <a16:creationId xmlns:a16="http://schemas.microsoft.com/office/drawing/2014/main" id="{1B5DA717-32E5-E6D0-DFBE-CC583C144CEC}"/>
              </a:ext>
            </a:extLst>
          </p:cNvPr>
          <p:cNvCxnSpPr>
            <a:cxnSpLocks/>
          </p:cNvCxnSpPr>
          <p:nvPr/>
        </p:nvCxnSpPr>
        <p:spPr>
          <a:xfrm>
            <a:off x="2722727" y="3466534"/>
            <a:ext cx="383679" cy="0"/>
          </a:xfrm>
          <a:prstGeom prst="straightConnector1">
            <a:avLst/>
          </a:prstGeom>
          <a:ln w="57150"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16" name="直接箭头连接符 15">
            <a:extLst>
              <a:ext uri="{FF2B5EF4-FFF2-40B4-BE49-F238E27FC236}">
                <a16:creationId xmlns:a16="http://schemas.microsoft.com/office/drawing/2014/main" id="{8E59C2FB-0C38-6704-46D8-E5169B0BD491}"/>
              </a:ext>
            </a:extLst>
          </p:cNvPr>
          <p:cNvCxnSpPr>
            <a:cxnSpLocks/>
          </p:cNvCxnSpPr>
          <p:nvPr/>
        </p:nvCxnSpPr>
        <p:spPr>
          <a:xfrm>
            <a:off x="5890512" y="3466534"/>
            <a:ext cx="383679" cy="0"/>
          </a:xfrm>
          <a:prstGeom prst="straightConnector1">
            <a:avLst/>
          </a:prstGeom>
          <a:ln w="57150"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17" name="直接箭头连接符 16">
            <a:extLst>
              <a:ext uri="{FF2B5EF4-FFF2-40B4-BE49-F238E27FC236}">
                <a16:creationId xmlns:a16="http://schemas.microsoft.com/office/drawing/2014/main" id="{50A281E8-2993-63AC-B15F-AD9C475F240F}"/>
              </a:ext>
            </a:extLst>
          </p:cNvPr>
          <p:cNvCxnSpPr>
            <a:cxnSpLocks/>
          </p:cNvCxnSpPr>
          <p:nvPr/>
        </p:nvCxnSpPr>
        <p:spPr>
          <a:xfrm>
            <a:off x="9053199" y="3466534"/>
            <a:ext cx="383679" cy="0"/>
          </a:xfrm>
          <a:prstGeom prst="straightConnector1">
            <a:avLst/>
          </a:prstGeom>
          <a:ln w="57150"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18" name="TextBox 3">
            <a:extLst>
              <a:ext uri="{FF2B5EF4-FFF2-40B4-BE49-F238E27FC236}">
                <a16:creationId xmlns:a16="http://schemas.microsoft.com/office/drawing/2014/main" id="{13F7EE7C-0ECA-4EE2-2F7F-B33E93DC8469}"/>
              </a:ext>
            </a:extLst>
          </p:cNvPr>
          <p:cNvSpPr txBox="1"/>
          <p:nvPr/>
        </p:nvSpPr>
        <p:spPr>
          <a:xfrm>
            <a:off x="-103828" y="842432"/>
            <a:ext cx="767549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 Gating strategies for CD24/Siglec-10</a:t>
            </a:r>
            <a:r>
              <a:rPr lang="zh-CN" altLang="en-US" sz="2000" b="1" dirty="0">
                <a:solidFill>
                  <a:prstClr val="black"/>
                </a:solidFill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 </a:t>
            </a:r>
            <a:r>
              <a:rPr lang="en-US" altLang="zh-CN" sz="2000" b="1" dirty="0">
                <a:solidFill>
                  <a:prstClr val="black"/>
                </a:solidFill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and PD-1/PD-L1 binding</a:t>
            </a:r>
            <a:endParaRPr kumimoji="0" lang="zh-CN" altLang="en-US" sz="20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271118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图片 14">
            <a:extLst>
              <a:ext uri="{FF2B5EF4-FFF2-40B4-BE49-F238E27FC236}">
                <a16:creationId xmlns:a16="http://schemas.microsoft.com/office/drawing/2014/main" id="{A5A6BA10-957D-7EBF-3F77-154E68B00EE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6565" y="1233712"/>
            <a:ext cx="2671241" cy="2412355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26FF204B-C2BC-68D6-5247-DAB068735B7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53366" y="1233713"/>
            <a:ext cx="2671241" cy="2412355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0CA7A0CA-E7CA-9E6E-A61A-63CE3A75800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860168" y="1233715"/>
            <a:ext cx="2775591" cy="2412355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BA18C539-67F6-3EB9-8E95-F50D2C49F24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46566" y="3907973"/>
            <a:ext cx="2681122" cy="2323639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B500659E-9396-2D5A-8592-E2647B43B43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253367" y="3907972"/>
            <a:ext cx="2671241" cy="2323640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BF59B946-78C7-CEAB-5D4A-FBBD2C2162B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860167" y="3985984"/>
            <a:ext cx="2633662" cy="2482448"/>
          </a:xfrm>
          <a:prstGeom prst="rect">
            <a:avLst/>
          </a:prstGeom>
        </p:spPr>
      </p:pic>
      <p:sp>
        <p:nvSpPr>
          <p:cNvPr id="26" name="TextBox 3">
            <a:extLst>
              <a:ext uri="{FF2B5EF4-FFF2-40B4-BE49-F238E27FC236}">
                <a16:creationId xmlns:a16="http://schemas.microsoft.com/office/drawing/2014/main" id="{8215E3BD-3126-0857-6EC0-DAE6FB2DFE22}"/>
              </a:ext>
            </a:extLst>
          </p:cNvPr>
          <p:cNvSpPr txBox="1"/>
          <p:nvPr/>
        </p:nvSpPr>
        <p:spPr>
          <a:xfrm>
            <a:off x="0" y="319918"/>
            <a:ext cx="608051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 Gating strategies for </a:t>
            </a:r>
            <a:r>
              <a:rPr lang="en-US" altLang="zh-CN" sz="2000" b="1" dirty="0">
                <a:solidFill>
                  <a:prstClr val="black"/>
                </a:solidFill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macrophage phagocytosis</a:t>
            </a:r>
            <a:endParaRPr lang="zh-CN" altLang="en-US" sz="2000" b="1" dirty="0">
              <a:solidFill>
                <a:prstClr val="black"/>
              </a:solidFill>
              <a:latin typeface="Arial" panose="020B0604020202020204" pitchFamily="34" charset="0"/>
              <a:ea typeface="微软雅黑" panose="020B0503020204020204" pitchFamily="34" charset="-122"/>
              <a:cs typeface="Arial" panose="020B0604020202020204" pitchFamily="34" charset="0"/>
            </a:endParaRPr>
          </a:p>
        </p:txBody>
      </p:sp>
      <p:cxnSp>
        <p:nvCxnSpPr>
          <p:cNvPr id="28" name="直接箭头连接符 27">
            <a:extLst>
              <a:ext uri="{FF2B5EF4-FFF2-40B4-BE49-F238E27FC236}">
                <a16:creationId xmlns:a16="http://schemas.microsoft.com/office/drawing/2014/main" id="{807336F5-A753-E75B-29FE-DDF3F40282B3}"/>
              </a:ext>
            </a:extLst>
          </p:cNvPr>
          <p:cNvCxnSpPr>
            <a:cxnSpLocks/>
          </p:cNvCxnSpPr>
          <p:nvPr/>
        </p:nvCxnSpPr>
        <p:spPr>
          <a:xfrm>
            <a:off x="3615355" y="2348935"/>
            <a:ext cx="383679" cy="0"/>
          </a:xfrm>
          <a:prstGeom prst="straightConnector1">
            <a:avLst/>
          </a:prstGeom>
          <a:ln w="57150"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29" name="直接箭头连接符 28">
            <a:extLst>
              <a:ext uri="{FF2B5EF4-FFF2-40B4-BE49-F238E27FC236}">
                <a16:creationId xmlns:a16="http://schemas.microsoft.com/office/drawing/2014/main" id="{ABD3464C-032E-E38D-E1E2-1D68B08D889A}"/>
              </a:ext>
            </a:extLst>
          </p:cNvPr>
          <p:cNvCxnSpPr>
            <a:cxnSpLocks/>
          </p:cNvCxnSpPr>
          <p:nvPr/>
        </p:nvCxnSpPr>
        <p:spPr>
          <a:xfrm>
            <a:off x="7243927" y="2399735"/>
            <a:ext cx="383679" cy="0"/>
          </a:xfrm>
          <a:prstGeom prst="straightConnector1">
            <a:avLst/>
          </a:prstGeom>
          <a:ln w="57150"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30" name="直接箭头连接符 29">
            <a:extLst>
              <a:ext uri="{FF2B5EF4-FFF2-40B4-BE49-F238E27FC236}">
                <a16:creationId xmlns:a16="http://schemas.microsoft.com/office/drawing/2014/main" id="{417F6D1F-A068-481E-6BAC-F142C3C4EB92}"/>
              </a:ext>
            </a:extLst>
          </p:cNvPr>
          <p:cNvCxnSpPr>
            <a:cxnSpLocks/>
          </p:cNvCxnSpPr>
          <p:nvPr/>
        </p:nvCxnSpPr>
        <p:spPr>
          <a:xfrm>
            <a:off x="11046670" y="2348935"/>
            <a:ext cx="383679" cy="0"/>
          </a:xfrm>
          <a:prstGeom prst="straightConnector1">
            <a:avLst/>
          </a:prstGeom>
          <a:ln w="57150"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31" name="直接箭头连接符 30">
            <a:extLst>
              <a:ext uri="{FF2B5EF4-FFF2-40B4-BE49-F238E27FC236}">
                <a16:creationId xmlns:a16="http://schemas.microsoft.com/office/drawing/2014/main" id="{BC4F69D4-5C24-8B6A-5EC0-B62984C05C84}"/>
              </a:ext>
            </a:extLst>
          </p:cNvPr>
          <p:cNvCxnSpPr>
            <a:cxnSpLocks/>
          </p:cNvCxnSpPr>
          <p:nvPr/>
        </p:nvCxnSpPr>
        <p:spPr>
          <a:xfrm>
            <a:off x="3680670" y="4961506"/>
            <a:ext cx="383679" cy="0"/>
          </a:xfrm>
          <a:prstGeom prst="straightConnector1">
            <a:avLst/>
          </a:prstGeom>
          <a:ln w="57150"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32" name="直接箭头连接符 31">
            <a:extLst>
              <a:ext uri="{FF2B5EF4-FFF2-40B4-BE49-F238E27FC236}">
                <a16:creationId xmlns:a16="http://schemas.microsoft.com/office/drawing/2014/main" id="{534198B3-D4E0-098F-A100-86BE4827EA71}"/>
              </a:ext>
            </a:extLst>
          </p:cNvPr>
          <p:cNvCxnSpPr>
            <a:cxnSpLocks/>
          </p:cNvCxnSpPr>
          <p:nvPr/>
        </p:nvCxnSpPr>
        <p:spPr>
          <a:xfrm>
            <a:off x="7243927" y="5026821"/>
            <a:ext cx="383679" cy="0"/>
          </a:xfrm>
          <a:prstGeom prst="straightConnector1">
            <a:avLst/>
          </a:prstGeom>
          <a:ln w="57150"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549351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7DDD9C6C-FAED-99E9-5E3D-D68C65D3328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6809" y="1299578"/>
            <a:ext cx="2482335" cy="2321736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616B2B25-D90A-7A2A-568E-88EA10E50C13}"/>
              </a:ext>
            </a:extLst>
          </p:cNvPr>
          <p:cNvSpPr txBox="1"/>
          <p:nvPr/>
        </p:nvSpPr>
        <p:spPr>
          <a:xfrm>
            <a:off x="1382869" y="3657529"/>
            <a:ext cx="122180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R="0" lvl="0" indent="0" defTabSz="457200" fontAlgn="auto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kumimoji="0" sz="2000" b="1" i="0" u="none" strike="noStrike" cap="none" spc="0" normalizeH="0" baseline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sz="1600" dirty="0"/>
              <a:t>Live/Death</a:t>
            </a:r>
            <a:endParaRPr lang="zh-CN" altLang="en-US" sz="1600" dirty="0"/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AB9E92F3-8292-5F29-A5C7-3B7CC8EA544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80559" y="1305806"/>
            <a:ext cx="2465671" cy="2309398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DB53DBD5-8A2F-B19D-15DD-45A8ED75B7D3}"/>
              </a:ext>
            </a:extLst>
          </p:cNvPr>
          <p:cNvSpPr txBox="1"/>
          <p:nvPr/>
        </p:nvSpPr>
        <p:spPr>
          <a:xfrm>
            <a:off x="5179585" y="3632254"/>
            <a:ext cx="70724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R="0" lvl="0" indent="0" defTabSz="457200" fontAlgn="auto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kumimoji="0" sz="1600" b="1" i="0" u="none" strike="noStrike" cap="none" spc="0" normalizeH="0" baseline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CD45</a:t>
            </a:r>
            <a:endParaRPr lang="zh-CN" altLang="en-US" dirty="0"/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1F5D0903-1EE2-8A34-4B5A-896C2CE3D8F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490437" y="1296883"/>
            <a:ext cx="2482335" cy="2327847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EDF68068-D454-4753-41C9-9B9E550D71E6}"/>
              </a:ext>
            </a:extLst>
          </p:cNvPr>
          <p:cNvSpPr txBox="1"/>
          <p:nvPr/>
        </p:nvSpPr>
        <p:spPr>
          <a:xfrm>
            <a:off x="8830425" y="3615204"/>
            <a:ext cx="5934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R="0" lvl="0" indent="0" defTabSz="457200" fontAlgn="auto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kumimoji="0" sz="1600" b="1" i="0" u="none" strike="noStrike" cap="none" spc="0" normalizeH="0" baseline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CD3</a:t>
            </a:r>
            <a:endParaRPr lang="zh-CN" altLang="en-US" dirty="0"/>
          </a:p>
        </p:txBody>
      </p:sp>
      <p:grpSp>
        <p:nvGrpSpPr>
          <p:cNvPr id="20" name="组合 19">
            <a:extLst>
              <a:ext uri="{FF2B5EF4-FFF2-40B4-BE49-F238E27FC236}">
                <a16:creationId xmlns:a16="http://schemas.microsoft.com/office/drawing/2014/main" id="{C29CF957-D781-4A4F-98D6-ACF106B74FA9}"/>
              </a:ext>
            </a:extLst>
          </p:cNvPr>
          <p:cNvGrpSpPr/>
          <p:nvPr/>
        </p:nvGrpSpPr>
        <p:grpSpPr>
          <a:xfrm>
            <a:off x="539934" y="4209143"/>
            <a:ext cx="2399210" cy="2583041"/>
            <a:chOff x="710373" y="3673209"/>
            <a:chExt cx="2399210" cy="2583041"/>
          </a:xfrm>
        </p:grpSpPr>
        <p:pic>
          <p:nvPicPr>
            <p:cNvPr id="12" name="图片 11">
              <a:extLst>
                <a:ext uri="{FF2B5EF4-FFF2-40B4-BE49-F238E27FC236}">
                  <a16:creationId xmlns:a16="http://schemas.microsoft.com/office/drawing/2014/main" id="{3168D547-9D12-BB93-88C9-8691E4F4F40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10373" y="3673209"/>
              <a:ext cx="2399210" cy="2243768"/>
            </a:xfrm>
            <a:prstGeom prst="rect">
              <a:avLst/>
            </a:prstGeom>
          </p:spPr>
        </p:pic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86EE508C-6735-42E5-F8F0-8314B841C1E6}"/>
                </a:ext>
              </a:extLst>
            </p:cNvPr>
            <p:cNvSpPr txBox="1"/>
            <p:nvPr/>
          </p:nvSpPr>
          <p:spPr>
            <a:xfrm>
              <a:off x="1868415" y="5917696"/>
              <a:ext cx="59343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R="0" lvl="0" indent="0" defTabSz="457200" fontAlgn="auto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1600" b="1" i="0" u="none" strike="noStrike" cap="none" spc="0" normalizeH="0" baseline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defRPr>
              </a:lvl1pPr>
            </a:lstStyle>
            <a:p>
              <a:r>
                <a:rPr lang="en-US" altLang="zh-CN" dirty="0"/>
                <a:t>CD8</a:t>
              </a:r>
              <a:endParaRPr lang="zh-CN" altLang="en-US" dirty="0"/>
            </a:p>
          </p:txBody>
        </p:sp>
      </p:grpSp>
      <p:grpSp>
        <p:nvGrpSpPr>
          <p:cNvPr id="19" name="组合 18">
            <a:extLst>
              <a:ext uri="{FF2B5EF4-FFF2-40B4-BE49-F238E27FC236}">
                <a16:creationId xmlns:a16="http://schemas.microsoft.com/office/drawing/2014/main" id="{52054B69-0DE6-FDA1-E8C5-6C8C48FE1529}"/>
              </a:ext>
            </a:extLst>
          </p:cNvPr>
          <p:cNvGrpSpPr/>
          <p:nvPr/>
        </p:nvGrpSpPr>
        <p:grpSpPr>
          <a:xfrm>
            <a:off x="3936073" y="4178607"/>
            <a:ext cx="2660198" cy="2559912"/>
            <a:chOff x="5297809" y="3673209"/>
            <a:chExt cx="2660198" cy="2559912"/>
          </a:xfrm>
        </p:grpSpPr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0554BD75-4BDF-74C9-DE26-C59264C5BE4B}"/>
                </a:ext>
              </a:extLst>
            </p:cNvPr>
            <p:cNvSpPr txBox="1"/>
            <p:nvPr/>
          </p:nvSpPr>
          <p:spPr>
            <a:xfrm>
              <a:off x="6743061" y="5894567"/>
              <a:ext cx="59343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R="0" lvl="0" indent="0" defTabSz="457200" fontAlgn="auto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1600" b="1" i="0" u="none" strike="noStrike" cap="none" spc="0" normalizeH="0" baseline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defRPr>
              </a:lvl1pPr>
            </a:lstStyle>
            <a:p>
              <a:r>
                <a:rPr lang="en-US" altLang="zh-CN" dirty="0"/>
                <a:t>CD8</a:t>
              </a:r>
              <a:endParaRPr lang="zh-CN" altLang="en-US" dirty="0"/>
            </a:p>
          </p:txBody>
        </p:sp>
        <p:pic>
          <p:nvPicPr>
            <p:cNvPr id="14" name="图片 13">
              <a:extLst>
                <a:ext uri="{FF2B5EF4-FFF2-40B4-BE49-F238E27FC236}">
                  <a16:creationId xmlns:a16="http://schemas.microsoft.com/office/drawing/2014/main" id="{D550D85B-0FC0-B47B-5020-4752BCAEE72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609485" y="3673209"/>
              <a:ext cx="2348522" cy="2243768"/>
            </a:xfrm>
            <a:prstGeom prst="rect">
              <a:avLst/>
            </a:prstGeom>
          </p:spPr>
        </p:pic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607CA6EF-CAA6-75E2-5BDF-7E29EE92F382}"/>
                </a:ext>
              </a:extLst>
            </p:cNvPr>
            <p:cNvSpPr txBox="1"/>
            <p:nvPr/>
          </p:nvSpPr>
          <p:spPr>
            <a:xfrm rot="16200000">
              <a:off x="5113463" y="4295657"/>
              <a:ext cx="70724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R="0" lvl="0" indent="0" defTabSz="457200" fontAlgn="auto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kumimoji="0" sz="1600" b="1" i="0" u="none" strike="noStrike" cap="none" spc="0" normalizeH="0" baseline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pitchFamily="34" charset="-122"/>
                  <a:cs typeface="Arial" panose="020B0604020202020204" pitchFamily="34" charset="0"/>
                </a:defRPr>
              </a:lvl1pPr>
            </a:lstStyle>
            <a:p>
              <a:r>
                <a:rPr lang="en-US" altLang="zh-CN" dirty="0"/>
                <a:t>CD45</a:t>
              </a:r>
              <a:endParaRPr lang="zh-CN" altLang="en-US" dirty="0"/>
            </a:p>
          </p:txBody>
        </p:sp>
      </p:grpSp>
      <p:cxnSp>
        <p:nvCxnSpPr>
          <p:cNvPr id="21" name="直接箭头连接符 20">
            <a:extLst>
              <a:ext uri="{FF2B5EF4-FFF2-40B4-BE49-F238E27FC236}">
                <a16:creationId xmlns:a16="http://schemas.microsoft.com/office/drawing/2014/main" id="{8AB7A100-82FF-413D-6AF1-F6997B475748}"/>
              </a:ext>
            </a:extLst>
          </p:cNvPr>
          <p:cNvCxnSpPr>
            <a:cxnSpLocks/>
          </p:cNvCxnSpPr>
          <p:nvPr/>
        </p:nvCxnSpPr>
        <p:spPr>
          <a:xfrm>
            <a:off x="3390384" y="2211049"/>
            <a:ext cx="383679" cy="0"/>
          </a:xfrm>
          <a:prstGeom prst="straightConnector1">
            <a:avLst/>
          </a:prstGeom>
          <a:ln w="57150"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22" name="直接箭头连接符 21">
            <a:extLst>
              <a:ext uri="{FF2B5EF4-FFF2-40B4-BE49-F238E27FC236}">
                <a16:creationId xmlns:a16="http://schemas.microsoft.com/office/drawing/2014/main" id="{57BC871F-E5BD-3E20-57B5-EEBA518A81AF}"/>
              </a:ext>
            </a:extLst>
          </p:cNvPr>
          <p:cNvCxnSpPr>
            <a:cxnSpLocks/>
          </p:cNvCxnSpPr>
          <p:nvPr/>
        </p:nvCxnSpPr>
        <p:spPr>
          <a:xfrm>
            <a:off x="6837051" y="2240079"/>
            <a:ext cx="383679" cy="0"/>
          </a:xfrm>
          <a:prstGeom prst="straightConnector1">
            <a:avLst/>
          </a:prstGeom>
          <a:ln w="57150"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23" name="直接箭头连接符 22">
            <a:extLst>
              <a:ext uri="{FF2B5EF4-FFF2-40B4-BE49-F238E27FC236}">
                <a16:creationId xmlns:a16="http://schemas.microsoft.com/office/drawing/2014/main" id="{A3E97FA9-643C-D165-7864-DDA45C57C5FE}"/>
              </a:ext>
            </a:extLst>
          </p:cNvPr>
          <p:cNvCxnSpPr>
            <a:cxnSpLocks/>
          </p:cNvCxnSpPr>
          <p:nvPr/>
        </p:nvCxnSpPr>
        <p:spPr>
          <a:xfrm>
            <a:off x="3390384" y="5106649"/>
            <a:ext cx="383679" cy="0"/>
          </a:xfrm>
          <a:prstGeom prst="straightConnector1">
            <a:avLst/>
          </a:prstGeom>
          <a:ln w="57150"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24" name="直接箭头连接符 23">
            <a:extLst>
              <a:ext uri="{FF2B5EF4-FFF2-40B4-BE49-F238E27FC236}">
                <a16:creationId xmlns:a16="http://schemas.microsoft.com/office/drawing/2014/main" id="{68F7B3DB-56AD-0F54-C683-FFF6A266466B}"/>
              </a:ext>
            </a:extLst>
          </p:cNvPr>
          <p:cNvCxnSpPr>
            <a:cxnSpLocks/>
          </p:cNvCxnSpPr>
          <p:nvPr/>
        </p:nvCxnSpPr>
        <p:spPr>
          <a:xfrm>
            <a:off x="10393526" y="2201413"/>
            <a:ext cx="383679" cy="0"/>
          </a:xfrm>
          <a:prstGeom prst="straightConnector1">
            <a:avLst/>
          </a:prstGeom>
          <a:ln w="57150"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25" name="TextBox 3">
            <a:extLst>
              <a:ext uri="{FF2B5EF4-FFF2-40B4-BE49-F238E27FC236}">
                <a16:creationId xmlns:a16="http://schemas.microsoft.com/office/drawing/2014/main" id="{BEB8032E-E302-A92E-1D6F-B8FF043F2B2F}"/>
              </a:ext>
            </a:extLst>
          </p:cNvPr>
          <p:cNvSpPr txBox="1"/>
          <p:nvPr/>
        </p:nvSpPr>
        <p:spPr>
          <a:xfrm>
            <a:off x="0" y="319918"/>
            <a:ext cx="608051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R="0" lvl="0" indent="0" defTabSz="457200" fontAlgn="auto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kumimoji="0" sz="2000" b="1" i="0" u="none" strike="noStrike" cap="none" spc="0" normalizeH="0" baseline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 Gating strategies </a:t>
            </a:r>
            <a:r>
              <a:rPr lang="en-US" altLang="zh-CN"/>
              <a:t>for </a:t>
            </a:r>
            <a:r>
              <a:rPr lang="en-US" altLang="zh-CN" dirty="0"/>
              <a:t>tumor-infiltrating immune cells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6590906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88</TotalTime>
  <Words>33</Words>
  <Application>Microsoft Office PowerPoint</Application>
  <PresentationFormat>宽屏</PresentationFormat>
  <Paragraphs>9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7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 Li</dc:creator>
  <cp:lastModifiedBy>Li Li</cp:lastModifiedBy>
  <cp:revision>7</cp:revision>
  <dcterms:created xsi:type="dcterms:W3CDTF">2025-02-28T01:14:11Z</dcterms:created>
  <dcterms:modified xsi:type="dcterms:W3CDTF">2025-02-28T14:22:28Z</dcterms:modified>
</cp:coreProperties>
</file>